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9" r:id="rId3"/>
    <p:sldId id="258" r:id="rId4"/>
    <p:sldId id="257" r:id="rId5"/>
  </p:sldIdLst>
  <p:sldSz cx="6858000" cy="9144000" type="screen4x3"/>
  <p:notesSz cx="6797675" cy="98742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016" autoAdjust="0"/>
    <p:restoredTop sz="94660"/>
  </p:normalViewPr>
  <p:slideViewPr>
    <p:cSldViewPr>
      <p:cViewPr>
        <p:scale>
          <a:sx n="130" d="100"/>
          <a:sy n="130" d="100"/>
        </p:scale>
        <p:origin x="-270" y="19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Relationship Id="rId9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6FF5E5-D371-4D2C-8C2E-19A9F27CD7F4}" type="datetimeFigureOut">
              <a:rPr lang="es-ES" smtClean="0"/>
              <a:t>04/02/2020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5075"/>
            <a:ext cx="2498725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51388"/>
            <a:ext cx="5438775" cy="38893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2AB4A9-2B9A-4469-9DD8-942D912C63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2361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y </a:t>
            </a:r>
            <a:r>
              <a:rPr lang="en-US" sz="1200" baseline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ublets</a:t>
            </a:r>
            <a:endParaRPr lang="es-E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2AB4A9-2B9A-4469-9DD8-942D912C637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7951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3533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525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4469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3104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5791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4400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5102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9610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8695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0655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4312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DCAA0-ED4C-456F-B127-F5780B5E18B3}" type="datetimeFigureOut">
              <a:rPr lang="es-ES" smtClean="0"/>
              <a:pPr/>
              <a:t>04/02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681A6-8344-4012-A30B-6A3D62F70533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6559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0.emf"/><Relationship Id="rId20" Type="http://schemas.openxmlformats.org/officeDocument/2006/relationships/image" Target="../media/image12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7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CuadroTexto 1"/>
          <p:cNvSpPr txBox="1"/>
          <p:nvPr/>
        </p:nvSpPr>
        <p:spPr>
          <a:xfrm>
            <a:off x="0" y="0"/>
            <a:ext cx="1196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V="1">
            <a:off x="499283" y="899592"/>
            <a:ext cx="0" cy="151216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499283" y="2418996"/>
            <a:ext cx="1777589" cy="608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 rot="16200000">
            <a:off x="101086" y="1082345"/>
            <a:ext cx="5809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579186" y="2411760"/>
            <a:ext cx="625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91560" y="2843808"/>
            <a:ext cx="59897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each sample, FSC/SSC profiles including a defined gate f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ukocytes were obtained (left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). FSC-H/FSC-A profiles within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ukocyte gate indicat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ts. DAPI negative cells within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gated t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 alive cells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CuadroTexto 2"/>
          <p:cNvSpPr txBox="1"/>
          <p:nvPr/>
        </p:nvSpPr>
        <p:spPr>
          <a:xfrm>
            <a:off x="332656" y="5395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uadroTexto 2"/>
          <p:cNvSpPr txBox="1"/>
          <p:nvPr/>
        </p:nvSpPr>
        <p:spPr>
          <a:xfrm>
            <a:off x="2348880" y="5395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uadroTexto 2"/>
          <p:cNvSpPr txBox="1"/>
          <p:nvPr/>
        </p:nvSpPr>
        <p:spPr>
          <a:xfrm>
            <a:off x="4429870" y="5395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Arrow Connector 35"/>
          <p:cNvCxnSpPr/>
          <p:nvPr/>
        </p:nvCxnSpPr>
        <p:spPr>
          <a:xfrm flipV="1">
            <a:off x="2515507" y="899592"/>
            <a:ext cx="0" cy="151216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2515507" y="2418996"/>
            <a:ext cx="1777589" cy="608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 rot="16200000">
            <a:off x="2117310" y="1082345"/>
            <a:ext cx="5809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595410" y="2411760"/>
            <a:ext cx="625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Arrow Connector 39"/>
          <p:cNvCxnSpPr/>
          <p:nvPr/>
        </p:nvCxnSpPr>
        <p:spPr>
          <a:xfrm flipV="1">
            <a:off x="4603739" y="899592"/>
            <a:ext cx="0" cy="151216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>
            <a:off x="4603739" y="2418996"/>
            <a:ext cx="1777589" cy="608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 rot="16200000">
            <a:off x="4205542" y="1082345"/>
            <a:ext cx="5809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683642" y="2411760"/>
            <a:ext cx="625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0834" b="6374"/>
          <a:stretch/>
        </p:blipFill>
        <p:spPr>
          <a:xfrm>
            <a:off x="548680" y="755576"/>
            <a:ext cx="1630660" cy="166744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/>
          <a:srcRect l="10834" b="6374"/>
          <a:stretch/>
        </p:blipFill>
        <p:spPr>
          <a:xfrm>
            <a:off x="2571517" y="755576"/>
            <a:ext cx="1630660" cy="166744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/>
          <a:srcRect l="9793" b="7462"/>
          <a:stretch/>
        </p:blipFill>
        <p:spPr>
          <a:xfrm>
            <a:off x="4603739" y="732015"/>
            <a:ext cx="1649710" cy="16674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87461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88640" y="6821087"/>
            <a:ext cx="655272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FN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20 ng/ml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FN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0) and 50 ng/ml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FN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0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Blood leukocytes 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 with the different doses of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FN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dia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ne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alua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ay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loo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US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D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a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by mean percentages of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US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D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(mean + SEM; n = 3) (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In other experiments, 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sor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tinyilat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b fragment of anti-IgM 1.14 and then incubated with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F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s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ve cells are show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+ SEM; n =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 secreting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cultures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quantificat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spot-form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ean + SEM; n =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) (C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hagocytic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acity of bloo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IgM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ratio of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gocytic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ratio of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ly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gocytic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s-E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entre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and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mea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FI) of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naliz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ad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gocytic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ean + SEM; n = 3)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ote significant differences betw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 treat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F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ontrol sampl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0.05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uadroTexto 1"/>
          <p:cNvSpPr txBox="1"/>
          <p:nvPr/>
        </p:nvSpPr>
        <p:spPr>
          <a:xfrm>
            <a:off x="0" y="0"/>
            <a:ext cx="1196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7313321"/>
              </p:ext>
            </p:extLst>
          </p:nvPr>
        </p:nvGraphicFramePr>
        <p:xfrm>
          <a:off x="4247708" y="541834"/>
          <a:ext cx="1685221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2" name="Prism 8" r:id="rId3" imgW="2599460" imgH="2876910" progId="Prism8.Document">
                  <p:embed/>
                </p:oleObj>
              </mc:Choice>
              <mc:Fallback>
                <p:oleObj name="Prism 8" r:id="rId3" imgW="2599460" imgH="287691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47708" y="541834"/>
                        <a:ext cx="1685221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6920029"/>
              </p:ext>
            </p:extLst>
          </p:nvPr>
        </p:nvGraphicFramePr>
        <p:xfrm>
          <a:off x="2168525" y="556775"/>
          <a:ext cx="1892731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3" name="Prism 8" r:id="rId5" imgW="2855516" imgH="2814604" progId="Prism8.Document">
                  <p:embed/>
                </p:oleObj>
              </mc:Choice>
              <mc:Fallback>
                <p:oleObj name="Prism 8" r:id="rId5" imgW="2855516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68525" y="556775"/>
                        <a:ext cx="1892731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1191468"/>
              </p:ext>
            </p:extLst>
          </p:nvPr>
        </p:nvGraphicFramePr>
        <p:xfrm>
          <a:off x="448338" y="547523"/>
          <a:ext cx="1720187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4" name="Prism 8" r:id="rId7" imgW="2594778" imgH="2814604" progId="Prism8.Document">
                  <p:embed/>
                </p:oleObj>
              </mc:Choice>
              <mc:Fallback>
                <p:oleObj name="Prism 8" r:id="rId7" imgW="2594778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8338" y="547523"/>
                        <a:ext cx="1720187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CuadroTexto 2"/>
          <p:cNvSpPr txBox="1"/>
          <p:nvPr/>
        </p:nvSpPr>
        <p:spPr>
          <a:xfrm>
            <a:off x="613446" y="3235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uadroTexto 2"/>
          <p:cNvSpPr txBox="1"/>
          <p:nvPr/>
        </p:nvSpPr>
        <p:spPr>
          <a:xfrm>
            <a:off x="2492896" y="3235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uadroTexto 2"/>
          <p:cNvSpPr txBox="1"/>
          <p:nvPr/>
        </p:nvSpPr>
        <p:spPr>
          <a:xfrm>
            <a:off x="4429870" y="3235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90938"/>
              </p:ext>
            </p:extLst>
          </p:nvPr>
        </p:nvGraphicFramePr>
        <p:xfrm>
          <a:off x="2168525" y="2836390"/>
          <a:ext cx="1891679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5" name="Prism 8" r:id="rId9" imgW="2854076" imgH="2814604" progId="Prism8.Document">
                  <p:embed/>
                </p:oleObj>
              </mc:Choice>
              <mc:Fallback>
                <p:oleObj name="Prism 8" r:id="rId9" imgW="2854076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68525" y="2836390"/>
                        <a:ext cx="1891679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5616920"/>
              </p:ext>
            </p:extLst>
          </p:nvPr>
        </p:nvGraphicFramePr>
        <p:xfrm>
          <a:off x="299090" y="2836390"/>
          <a:ext cx="1894835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6" name="Prism 8" r:id="rId11" imgW="2858757" imgH="2814604" progId="Prism8.Document">
                  <p:embed/>
                </p:oleObj>
              </mc:Choice>
              <mc:Fallback>
                <p:oleObj name="Prism 8" r:id="rId11" imgW="2858757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99090" y="2836390"/>
                        <a:ext cx="1894835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CuadroTexto 2"/>
          <p:cNvSpPr txBox="1"/>
          <p:nvPr/>
        </p:nvSpPr>
        <p:spPr>
          <a:xfrm>
            <a:off x="613446" y="261903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327721"/>
              </p:ext>
            </p:extLst>
          </p:nvPr>
        </p:nvGraphicFramePr>
        <p:xfrm>
          <a:off x="303406" y="4947153"/>
          <a:ext cx="1894835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7" name="Prism 8" r:id="rId13" imgW="2858757" imgH="2814604" progId="Prism8.Document">
                  <p:embed/>
                </p:oleObj>
              </mc:Choice>
              <mc:Fallback>
                <p:oleObj name="Prism 8" r:id="rId13" imgW="2858757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03406" y="4947153"/>
                        <a:ext cx="1894835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6868684"/>
              </p:ext>
            </p:extLst>
          </p:nvPr>
        </p:nvGraphicFramePr>
        <p:xfrm>
          <a:off x="2167855" y="4938595"/>
          <a:ext cx="1891679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8" name="Prism 8" r:id="rId15" imgW="2854076" imgH="2814604" progId="Prism8.Document">
                  <p:embed/>
                </p:oleObj>
              </mc:Choice>
              <mc:Fallback>
                <p:oleObj name="Prism 8" r:id="rId15" imgW="2854076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167855" y="4938595"/>
                        <a:ext cx="1891679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0599296"/>
              </p:ext>
            </p:extLst>
          </p:nvPr>
        </p:nvGraphicFramePr>
        <p:xfrm>
          <a:off x="4106843" y="2836390"/>
          <a:ext cx="1831709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9" name="Prism 8" r:id="rId17" imgW="2764042" imgH="2814604" progId="Prism8.Document">
                  <p:embed/>
                </p:oleObj>
              </mc:Choice>
              <mc:Fallback>
                <p:oleObj name="Prism 8" r:id="rId17" imgW="2764042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106843" y="2836390"/>
                        <a:ext cx="1831709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0550915"/>
              </p:ext>
            </p:extLst>
          </p:nvPr>
        </p:nvGraphicFramePr>
        <p:xfrm>
          <a:off x="4101220" y="4938595"/>
          <a:ext cx="1831709" cy="1865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0" name="Prism 8" r:id="rId19" imgW="2764042" imgH="2814604" progId="Prism8.Document">
                  <p:embed/>
                </p:oleObj>
              </mc:Choice>
              <mc:Fallback>
                <p:oleObj name="Prism 8" r:id="rId19" imgW="2764042" imgH="2814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101220" y="4938595"/>
                        <a:ext cx="1831709" cy="1865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91935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0"/>
          <p:cNvSpPr txBox="1"/>
          <p:nvPr/>
        </p:nvSpPr>
        <p:spPr>
          <a:xfrm>
            <a:off x="333093" y="3707904"/>
            <a:ext cx="59897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showing IgM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befor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upper panels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after their sortin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ower panels)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uadroTexto 1"/>
          <p:cNvSpPr txBox="1"/>
          <p:nvPr/>
        </p:nvSpPr>
        <p:spPr>
          <a:xfrm>
            <a:off x="0" y="0"/>
            <a:ext cx="1196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Imagen 2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6239"/>
          <a:stretch/>
        </p:blipFill>
        <p:spPr>
          <a:xfrm>
            <a:off x="430005" y="603579"/>
            <a:ext cx="1393919" cy="2613038"/>
          </a:xfrm>
          <a:prstGeom prst="rect">
            <a:avLst/>
          </a:prstGeom>
        </p:spPr>
      </p:pic>
      <p:grpSp>
        <p:nvGrpSpPr>
          <p:cNvPr id="11" name="Grupo 27"/>
          <p:cNvGrpSpPr/>
          <p:nvPr/>
        </p:nvGrpSpPr>
        <p:grpSpPr>
          <a:xfrm>
            <a:off x="314936" y="-83948"/>
            <a:ext cx="1920080" cy="3485230"/>
            <a:chOff x="233147" y="220104"/>
            <a:chExt cx="1920080" cy="3485230"/>
          </a:xfrm>
        </p:grpSpPr>
        <p:cxnSp>
          <p:nvCxnSpPr>
            <p:cNvPr id="12" name="Conector recto de flecha 5"/>
            <p:cNvCxnSpPr/>
            <p:nvPr/>
          </p:nvCxnSpPr>
          <p:spPr>
            <a:xfrm flipV="1">
              <a:off x="349909" y="1582467"/>
              <a:ext cx="0" cy="200107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CuadroTexto 6"/>
            <p:cNvSpPr txBox="1"/>
            <p:nvPr/>
          </p:nvSpPr>
          <p:spPr>
            <a:xfrm rot="16200000">
              <a:off x="-350324" y="803575"/>
              <a:ext cx="1413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Conector recto de flecha 8"/>
            <p:cNvCxnSpPr/>
            <p:nvPr/>
          </p:nvCxnSpPr>
          <p:spPr>
            <a:xfrm flipV="1">
              <a:off x="350734" y="3582224"/>
              <a:ext cx="868466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uadroTexto 9"/>
            <p:cNvSpPr txBox="1"/>
            <p:nvPr/>
          </p:nvSpPr>
          <p:spPr>
            <a:xfrm>
              <a:off x="1155700" y="3459113"/>
              <a:ext cx="9975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upo 28"/>
          <p:cNvGrpSpPr/>
          <p:nvPr/>
        </p:nvGrpSpPr>
        <p:grpSpPr>
          <a:xfrm>
            <a:off x="1823924" y="-236348"/>
            <a:ext cx="2085180" cy="3637630"/>
            <a:chOff x="1742135" y="67704"/>
            <a:chExt cx="2085180" cy="3637630"/>
          </a:xfrm>
        </p:grpSpPr>
        <p:cxnSp>
          <p:nvCxnSpPr>
            <p:cNvPr id="17" name="Conector recto de flecha 19"/>
            <p:cNvCxnSpPr/>
            <p:nvPr/>
          </p:nvCxnSpPr>
          <p:spPr>
            <a:xfrm flipV="1">
              <a:off x="1858897" y="1487217"/>
              <a:ext cx="0" cy="210312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uadroTexto 20"/>
            <p:cNvSpPr txBox="1"/>
            <p:nvPr/>
          </p:nvSpPr>
          <p:spPr>
            <a:xfrm rot="16200000">
              <a:off x="1158664" y="651175"/>
              <a:ext cx="14131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Conector recto de flecha 21"/>
            <p:cNvCxnSpPr/>
            <p:nvPr/>
          </p:nvCxnSpPr>
          <p:spPr>
            <a:xfrm flipV="1">
              <a:off x="1859722" y="3588574"/>
              <a:ext cx="1005840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uadroTexto 22"/>
            <p:cNvSpPr txBox="1"/>
            <p:nvPr/>
          </p:nvSpPr>
          <p:spPr>
            <a:xfrm>
              <a:off x="2829788" y="3459113"/>
              <a:ext cx="9975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gD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CuadroTexto 23"/>
          <p:cNvSpPr txBox="1"/>
          <p:nvPr/>
        </p:nvSpPr>
        <p:spPr>
          <a:xfrm>
            <a:off x="657851" y="748411"/>
            <a:ext cx="997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efore sorting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uadroTexto 24"/>
          <p:cNvSpPr txBox="1"/>
          <p:nvPr/>
        </p:nvSpPr>
        <p:spPr>
          <a:xfrm>
            <a:off x="691057" y="2001373"/>
            <a:ext cx="997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fter sorting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magen 2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91"/>
          <a:stretch/>
        </p:blipFill>
        <p:spPr>
          <a:xfrm>
            <a:off x="2046713" y="603580"/>
            <a:ext cx="1320469" cy="2613038"/>
          </a:xfrm>
          <a:prstGeom prst="rect">
            <a:avLst/>
          </a:prstGeom>
        </p:spPr>
      </p:pic>
      <p:sp>
        <p:nvSpPr>
          <p:cNvPr id="24" name="CuadroTexto 29"/>
          <p:cNvSpPr txBox="1"/>
          <p:nvPr/>
        </p:nvSpPr>
        <p:spPr>
          <a:xfrm>
            <a:off x="2235016" y="748411"/>
            <a:ext cx="9975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2.7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30"/>
          <p:cNvSpPr txBox="1"/>
          <p:nvPr/>
        </p:nvSpPr>
        <p:spPr>
          <a:xfrm>
            <a:off x="2235016" y="1996704"/>
            <a:ext cx="9975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99.8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03359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2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6136108"/>
              </p:ext>
            </p:extLst>
          </p:nvPr>
        </p:nvGraphicFramePr>
        <p:xfrm>
          <a:off x="260648" y="1763688"/>
          <a:ext cx="6172200" cy="3782441"/>
        </p:xfrm>
        <a:graphic>
          <a:graphicData uri="http://schemas.openxmlformats.org/drawingml/2006/table">
            <a:tbl>
              <a:tblPr firstRow="1" firstCol="1" bandRow="1"/>
              <a:tblGrid>
                <a:gridCol w="835716"/>
                <a:gridCol w="530809"/>
                <a:gridCol w="2682438"/>
                <a:gridCol w="2123237"/>
              </a:tblGrid>
              <a:tr h="1298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ene</a:t>
                      </a:r>
                      <a:endParaRPr lang="es-E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Sequences (5’ – 3’)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ccession number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98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b-actin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CCTTCCTCGGTATGGAGT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TACGGATGTCCACGTCAC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P_001117707.1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hcII (DAA)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CACCCTTATCTGCCACGTC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CTGGGGTGAAGCTCAGACT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J251432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d83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CTGTTGATAGCGGGAGG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GTGGACTCAAGGCAATCTG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Y263793.1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d80/86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TGTTTCCTGGTTCTGGTATC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ACTTGCTGCTCCCTTTCCTC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J467621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1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GACGAAGACCAACCCTTAACTG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CAGACGCTGACTGGATATCCAGTAG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M_001171901.1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2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AAATAATTTAGGGAGTTGGAAAGGGTTAC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AGACGCTGACTGGCAATATGATAA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M_001124751.1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3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AAGACGACCGACCCTTACCAAC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CAGACGCTGACTGGATATCCTGTAA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XM_021569609.1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4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AAAATACTTTAGGGAGTCAGAAAGGGTTCT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AGACGCTGACTGGCAATATGATAA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K301134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5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TCTACACACAGGATGAAATCTTCAACAAAGT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CAGTCTTTGCACCACAATCTCATAG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K301135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6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ACACAGGATGAAATCTTCAACAAAC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CAGTCTTTGCACCACAATCTCATAG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 smtClean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K301136</a:t>
                      </a:r>
                      <a:endParaRPr lang="es-E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7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CAGTTTGAGATGGAGATGTACACAC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CTGCACCACGATCTCAAAG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K301137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8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GATGAGATCTTCTTTGAAACATTGAATC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CGCTGCACCACGATCTCATAG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K301138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77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x9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Forward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Reverse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TACACTCAGGACAGTATTTTCATCAAGG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GGCGCTGGTAGACAATCTCATAGTA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MK301139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b="1" i="1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 </a:t>
                      </a:r>
                      <a:endParaRPr lang="es-ES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0701" marR="607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3 Rectángulo"/>
          <p:cNvSpPr/>
          <p:nvPr/>
        </p:nvSpPr>
        <p:spPr>
          <a:xfrm>
            <a:off x="332656" y="5796136"/>
            <a:ext cx="619268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quences used for gene express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b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l time RT-PCR.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uadroTexto 1"/>
          <p:cNvSpPr txBox="1"/>
          <p:nvPr/>
        </p:nvSpPr>
        <p:spPr>
          <a:xfrm>
            <a:off x="0" y="0"/>
            <a:ext cx="1196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50285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02</TotalTime>
  <Words>463</Words>
  <Application>Microsoft Office PowerPoint</Application>
  <PresentationFormat>Presentación en pantalla (4:3)</PresentationFormat>
  <Paragraphs>121</Paragraphs>
  <Slides>4</Slides>
  <Notes>1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6" baseType="lpstr">
      <vt:lpstr>Tema de Office</vt:lpstr>
      <vt:lpstr>Prism 8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olina Tafalla</dc:creator>
  <cp:lastModifiedBy>Carolina Tafalla</cp:lastModifiedBy>
  <cp:revision>398</cp:revision>
  <cp:lastPrinted>2019-06-14T08:47:33Z</cp:lastPrinted>
  <dcterms:created xsi:type="dcterms:W3CDTF">2018-05-10T11:02:11Z</dcterms:created>
  <dcterms:modified xsi:type="dcterms:W3CDTF">2020-02-04T12:54:48Z</dcterms:modified>
</cp:coreProperties>
</file>